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4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80" d="100"/>
          <a:sy n="80" d="100"/>
        </p:scale>
        <p:origin x="682" y="134"/>
      </p:cViewPr>
      <p:guideLst>
        <p:guide orient="horz" pos="2184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E2A217-38A4-4739-9008-06A66862F5EC}" type="datetimeFigureOut">
              <a:rPr lang="en-US" smtClean="0"/>
              <a:t>2/25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EB05FE-269D-4339-9625-F2A2CA987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4023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EB05FE-269D-4339-9625-F2A2CA98765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1853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1A154-7967-4C37-9339-7C194DC54E39}" type="datetimeFigureOut">
              <a:rPr lang="en-US" smtClean="0"/>
              <a:t>2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D5B1D-15CE-4226-A635-DC8FF50D5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9222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1A154-7967-4C37-9339-7C194DC54E39}" type="datetimeFigureOut">
              <a:rPr lang="en-US" smtClean="0"/>
              <a:t>2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D5B1D-15CE-4226-A635-DC8FF50D5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379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1A154-7967-4C37-9339-7C194DC54E39}" type="datetimeFigureOut">
              <a:rPr lang="en-US" smtClean="0"/>
              <a:t>2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D5B1D-15CE-4226-A635-DC8FF50D5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629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1A154-7967-4C37-9339-7C194DC54E39}" type="datetimeFigureOut">
              <a:rPr lang="en-US" smtClean="0"/>
              <a:t>2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D5B1D-15CE-4226-A635-DC8FF50D5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8940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1A154-7967-4C37-9339-7C194DC54E39}" type="datetimeFigureOut">
              <a:rPr lang="en-US" smtClean="0"/>
              <a:t>2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D5B1D-15CE-4226-A635-DC8FF50D5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235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1A154-7967-4C37-9339-7C194DC54E39}" type="datetimeFigureOut">
              <a:rPr lang="en-US" smtClean="0"/>
              <a:t>2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D5B1D-15CE-4226-A635-DC8FF50D5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455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1A154-7967-4C37-9339-7C194DC54E39}" type="datetimeFigureOut">
              <a:rPr lang="en-US" smtClean="0"/>
              <a:t>2/2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D5B1D-15CE-4226-A635-DC8FF50D5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82930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1A154-7967-4C37-9339-7C194DC54E39}" type="datetimeFigureOut">
              <a:rPr lang="en-US" smtClean="0"/>
              <a:t>2/2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D5B1D-15CE-4226-A635-DC8FF50D5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310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1A154-7967-4C37-9339-7C194DC54E39}" type="datetimeFigureOut">
              <a:rPr lang="en-US" smtClean="0"/>
              <a:t>2/2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D5B1D-15CE-4226-A635-DC8FF50D5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3600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1A154-7967-4C37-9339-7C194DC54E39}" type="datetimeFigureOut">
              <a:rPr lang="en-US" smtClean="0"/>
              <a:t>2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D5B1D-15CE-4226-A635-DC8FF50D5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48989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1A154-7967-4C37-9339-7C194DC54E39}" type="datetimeFigureOut">
              <a:rPr lang="en-US" smtClean="0"/>
              <a:t>2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D5B1D-15CE-4226-A635-DC8FF50D5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5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81A154-7967-4C37-9339-7C194DC54E39}" type="datetimeFigureOut">
              <a:rPr lang="en-US" smtClean="0"/>
              <a:t>2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2D5B1D-15CE-4226-A635-DC8FF50D5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4368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14300" y="1459937"/>
            <a:ext cx="441146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3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073547" y="1459937"/>
            <a:ext cx="441146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3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5215" y="2583584"/>
            <a:ext cx="5478905" cy="310896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13095" y="2583584"/>
            <a:ext cx="5478905" cy="310896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664611" y="0"/>
            <a:ext cx="1517162" cy="1919369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546707" y="256557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48764" y="302342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48029" y="348550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47368" y="394227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72634" y="4402855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75670" y="4859625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71860" y="5319402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-6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495532" y="5657214"/>
            <a:ext cx="167225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t>Ancestral</a:t>
            </a:r>
            <a:endParaRPr 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k</a:t>
            </a:r>
            <a:endParaRPr 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947162" y="5659639"/>
            <a:ext cx="167225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volved</a:t>
            </a:r>
          </a:p>
          <a:p>
            <a:pPr algn="ctr"/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k</a:t>
            </a:r>
            <a:endParaRPr 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7381919" y="5644629"/>
            <a:ext cx="16850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ncestral</a:t>
            </a:r>
          </a:p>
          <a:p>
            <a:pPr algn="ctr"/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ud</a:t>
            </a:r>
            <a:endParaRPr 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9833549" y="5647054"/>
            <a:ext cx="16850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volved</a:t>
            </a:r>
          </a:p>
          <a:p>
            <a:pPr algn="ctr"/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ud</a:t>
            </a:r>
            <a:endParaRPr 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-631705" y="3940841"/>
            <a:ext cx="17193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% of difference</a:t>
            </a:r>
            <a:endParaRPr 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443663" y="2564141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6445720" y="302198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6444985" y="348407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444324" y="394084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369590" y="4401422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6372626" y="4858192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368816" y="5317969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-6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941729" y="359497"/>
            <a:ext cx="825418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000" dirty="0" smtClean="0">
                <a:latin typeface="Arial" panose="020B0604020202020204" pitchFamily="34" charset="0"/>
                <a:cs typeface="Arial" panose="020B0604020202020204" pitchFamily="34" charset="0"/>
              </a:rPr>
              <a:t>Ethanol yield (%) </a:t>
            </a:r>
            <a:r>
              <a:rPr lang="en-US" sz="3000" dirty="0" smtClean="0">
                <a:latin typeface="Arial" panose="020B0604020202020204" pitchFamily="34" charset="0"/>
                <a:cs typeface="Arial" panose="020B0604020202020204" pitchFamily="34" charset="0"/>
              </a:rPr>
              <a:t>based on </a:t>
            </a:r>
            <a:r>
              <a:rPr lang="en-US" sz="3000" smtClean="0">
                <a:latin typeface="Arial" panose="020B0604020202020204" pitchFamily="34" charset="0"/>
                <a:cs typeface="Arial" panose="020B0604020202020204" pitchFamily="34" charset="0"/>
              </a:rPr>
              <a:t>xylose consumption</a:t>
            </a:r>
            <a:endParaRPr lang="en-US" sz="3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ight Bracket 2"/>
          <p:cNvSpPr/>
          <p:nvPr/>
        </p:nvSpPr>
        <p:spPr>
          <a:xfrm rot="16200000">
            <a:off x="4253250" y="965754"/>
            <a:ext cx="315858" cy="2486787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ight Bracket 30"/>
          <p:cNvSpPr/>
          <p:nvPr/>
        </p:nvSpPr>
        <p:spPr>
          <a:xfrm rot="16200000">
            <a:off x="3379871" y="1396869"/>
            <a:ext cx="315858" cy="2486787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ight Bracket 31"/>
          <p:cNvSpPr/>
          <p:nvPr/>
        </p:nvSpPr>
        <p:spPr>
          <a:xfrm rot="16200000">
            <a:off x="2914435" y="1770622"/>
            <a:ext cx="315858" cy="2486787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4149925" y="1776489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**</a:t>
            </a:r>
            <a:endParaRPr lang="en-US" dirty="0"/>
          </a:p>
        </p:txBody>
      </p:sp>
      <p:sp>
        <p:nvSpPr>
          <p:cNvPr id="34" name="Right Bracket 33"/>
          <p:cNvSpPr/>
          <p:nvPr/>
        </p:nvSpPr>
        <p:spPr>
          <a:xfrm rot="16200000">
            <a:off x="10153193" y="1017131"/>
            <a:ext cx="315858" cy="2486787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ight Bracket 34"/>
          <p:cNvSpPr/>
          <p:nvPr/>
        </p:nvSpPr>
        <p:spPr>
          <a:xfrm rot="16200000">
            <a:off x="9721763" y="1411865"/>
            <a:ext cx="315858" cy="2486787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ight Bracket 35"/>
          <p:cNvSpPr/>
          <p:nvPr/>
        </p:nvSpPr>
        <p:spPr>
          <a:xfrm rot="16200000">
            <a:off x="9279814" y="1806599"/>
            <a:ext cx="315858" cy="2486787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/>
          <p:cNvSpPr txBox="1"/>
          <p:nvPr/>
        </p:nvSpPr>
        <p:spPr>
          <a:xfrm>
            <a:off x="10045664" y="1845826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**</a:t>
            </a:r>
            <a:endParaRPr lang="en-US" dirty="0"/>
          </a:p>
        </p:txBody>
      </p:sp>
      <p:sp>
        <p:nvSpPr>
          <p:cNvPr id="39" name="TextBox 38"/>
          <p:cNvSpPr txBox="1"/>
          <p:nvPr/>
        </p:nvSpPr>
        <p:spPr>
          <a:xfrm>
            <a:off x="9618309" y="2255500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**</a:t>
            </a:r>
            <a:endParaRPr lang="en-US" dirty="0"/>
          </a:p>
        </p:txBody>
      </p:sp>
      <p:sp>
        <p:nvSpPr>
          <p:cNvPr id="40" name="TextBox 39"/>
          <p:cNvSpPr txBox="1"/>
          <p:nvPr/>
        </p:nvSpPr>
        <p:spPr>
          <a:xfrm>
            <a:off x="3462207" y="224704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41" name="TextBox 40"/>
          <p:cNvSpPr txBox="1"/>
          <p:nvPr/>
        </p:nvSpPr>
        <p:spPr>
          <a:xfrm>
            <a:off x="9302634" y="2665593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**</a:t>
            </a:r>
            <a:endParaRPr lang="en-US" dirty="0"/>
          </a:p>
        </p:txBody>
      </p:sp>
      <p:sp>
        <p:nvSpPr>
          <p:cNvPr id="42" name="TextBox 41"/>
          <p:cNvSpPr txBox="1"/>
          <p:nvPr/>
        </p:nvSpPr>
        <p:spPr>
          <a:xfrm>
            <a:off x="3022271" y="261352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160200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</TotalTime>
  <Words>71</Words>
  <Application>Microsoft Office PowerPoint</Application>
  <PresentationFormat>Widescreen</PresentationFormat>
  <Paragraphs>3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Peris</dc:creator>
  <cp:lastModifiedBy>David Peris</cp:lastModifiedBy>
  <cp:revision>14</cp:revision>
  <dcterms:created xsi:type="dcterms:W3CDTF">2017-01-26T00:04:56Z</dcterms:created>
  <dcterms:modified xsi:type="dcterms:W3CDTF">2017-02-25T17:46:11Z</dcterms:modified>
</cp:coreProperties>
</file>